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drawings/drawing1.xml" ContentType="application/vnd.openxmlformats-officedocument.drawingml.chartshapes+xml"/>
  <Override PartName="/ppt/drawings/drawing2.xml" ContentType="application/vnd.openxmlformats-officedocument.drawingml.chartshap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3" r:id="rId1"/>
  </p:sldMasterIdLst>
  <p:notesMasterIdLst>
    <p:notesMasterId r:id="rId4"/>
  </p:notesMasterIdLst>
  <p:sldIdLst>
    <p:sldId id="291" r:id="rId2"/>
    <p:sldId id="293" r:id="rId3"/>
  </p:sldIdLst>
  <p:sldSz cx="9144000" cy="6858000" type="screen4x3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00FA00"/>
    <a:srgbClr val="006600"/>
    <a:srgbClr val="003300"/>
    <a:srgbClr val="0047B0"/>
    <a:srgbClr val="0099FF"/>
    <a:srgbClr val="C80000"/>
    <a:srgbClr val="860000"/>
    <a:srgbClr val="800000"/>
    <a:srgbClr val="397DCF"/>
    <a:srgbClr val="1E497C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5" d="100"/>
          <a:sy n="65" d="100"/>
        </p:scale>
        <p:origin x="-46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Office_Excel_Worksheet1.xlsx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package" Target="../embeddings/Microsoft_Office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/>
      <c:barChart>
        <c:barDir val="col"/>
        <c:grouping val="stacked"/>
        <c:ser>
          <c:idx val="0"/>
          <c:order val="0"/>
          <c:tx>
            <c:strRef>
              <c:f>Sheet1!$B$1</c:f>
              <c:strCache>
                <c:ptCount val="1"/>
                <c:pt idx="0">
                  <c:v>Column1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c:spPr>
          <c:dPt>
            <c:idx val="2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cat>
            <c:strRef>
              <c:f>Sheet1!$A$2:$A$19</c:f>
              <c:strCache>
                <c:ptCount val="18"/>
                <c:pt idx="1">
                  <c:v>NGT</c:v>
                </c:pt>
                <c:pt idx="2">
                  <c:v>Pre</c:v>
                </c:pt>
                <c:pt idx="4">
                  <c:v>NGT</c:v>
                </c:pt>
                <c:pt idx="5">
                  <c:v>Pre</c:v>
                </c:pt>
                <c:pt idx="7">
                  <c:v>NGT</c:v>
                </c:pt>
                <c:pt idx="8">
                  <c:v>Pre</c:v>
                </c:pt>
                <c:pt idx="10">
                  <c:v>NGT</c:v>
                </c:pt>
                <c:pt idx="11">
                  <c:v>Pre</c:v>
                </c:pt>
                <c:pt idx="13">
                  <c:v>NGT</c:v>
                </c:pt>
                <c:pt idx="14">
                  <c:v>Pre</c:v>
                </c:pt>
                <c:pt idx="16">
                  <c:v>NGT</c:v>
                </c:pt>
                <c:pt idx="17">
                  <c:v>Pre</c:v>
                </c:pt>
              </c:strCache>
            </c:strRef>
          </c:cat>
          <c:val>
            <c:numRef>
              <c:f>Sheet1!$B$2:$B$19</c:f>
              <c:numCache>
                <c:formatCode>General</c:formatCode>
                <c:ptCount val="18"/>
                <c:pt idx="1">
                  <c:v>0.40410000000000001</c:v>
                </c:pt>
                <c:pt idx="2">
                  <c:v>0.60940000000000005</c:v>
                </c:pt>
                <c:pt idx="4">
                  <c:v>0.23319999999999999</c:v>
                </c:pt>
                <c:pt idx="5">
                  <c:v>0.40780000000000005</c:v>
                </c:pt>
                <c:pt idx="7">
                  <c:v>2.2600000000000002E-2</c:v>
                </c:pt>
                <c:pt idx="8">
                  <c:v>9.5000000000000015E-2</c:v>
                </c:pt>
                <c:pt idx="10">
                  <c:v>6.6700000000000009E-2</c:v>
                </c:pt>
                <c:pt idx="11">
                  <c:v>0.16560000000000002</c:v>
                </c:pt>
                <c:pt idx="13">
                  <c:v>0.17530000000000001</c:v>
                </c:pt>
                <c:pt idx="14">
                  <c:v>0.27830000000000005</c:v>
                </c:pt>
                <c:pt idx="16">
                  <c:v>9.830000000000004E-2</c:v>
                </c:pt>
                <c:pt idx="17">
                  <c:v>0.31220000000000003</c:v>
                </c:pt>
              </c:numCache>
            </c:numRef>
          </c:val>
        </c:ser>
        <c:dLbls/>
        <c:gapWidth val="16"/>
        <c:overlap val="100"/>
        <c:axId val="92296320"/>
        <c:axId val="92297856"/>
      </c:barChart>
      <c:catAx>
        <c:axId val="92296320"/>
        <c:scaling>
          <c:orientation val="minMax"/>
        </c:scaling>
        <c:axPos val="b"/>
        <c:numFmt formatCode="General" sourceLinked="0"/>
        <c:tickLblPos val="nextTo"/>
        <c:txPr>
          <a:bodyPr/>
          <a:lstStyle/>
          <a:p>
            <a:pPr>
              <a:defRPr sz="1200" baseline="0">
                <a:latin typeface="Arial" panose="020B0604020202020204" pitchFamily="34" charset="0"/>
              </a:defRPr>
            </a:pPr>
            <a:endParaRPr lang="en-US"/>
          </a:p>
        </c:txPr>
        <c:crossAx val="92297856"/>
        <c:crosses val="autoZero"/>
        <c:auto val="1"/>
        <c:lblAlgn val="ctr"/>
        <c:lblOffset val="100"/>
      </c:catAx>
      <c:valAx>
        <c:axId val="92297856"/>
        <c:scaling>
          <c:orientation val="minMax"/>
          <c:max val="0.70000000000000018"/>
        </c:scaling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 smtClean="0"/>
                  <a:t>Frequency</a:t>
                </a:r>
                <a:endParaRPr lang="en-US" dirty="0"/>
              </a:p>
            </c:rich>
          </c:tx>
          <c:layout/>
        </c:title>
        <c:numFmt formatCode="0%" sourceLinked="0"/>
        <c:tickLblPos val="nextTo"/>
        <c:txPr>
          <a:bodyPr/>
          <a:lstStyle/>
          <a:p>
            <a:pPr>
              <a:defRPr sz="16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92296320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1800"/>
      </a:pPr>
      <a:endParaRPr lang="en-US"/>
    </a:p>
  </c:txPr>
  <c:externalData r:id="rId1"/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autoTitleDeleted val="1"/>
    <c:plotArea>
      <c:layout/>
      <c:barChart>
        <c:barDir val="col"/>
        <c:grouping val="stacked"/>
        <c:ser>
          <c:idx val="0"/>
          <c:order val="0"/>
          <c:tx>
            <c:strRef>
              <c:f>Sheet1!$B$1</c:f>
              <c:strCache>
                <c:ptCount val="1"/>
                <c:pt idx="0">
                  <c:v>Column1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c:spPr>
          <c:dPt>
            <c:idx val="2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cat>
            <c:strRef>
              <c:f>Sheet1!$A$2:$A$19</c:f>
              <c:strCache>
                <c:ptCount val="18"/>
                <c:pt idx="1">
                  <c:v>NGT</c:v>
                </c:pt>
                <c:pt idx="2">
                  <c:v>Pre</c:v>
                </c:pt>
                <c:pt idx="4">
                  <c:v>NGT</c:v>
                </c:pt>
                <c:pt idx="5">
                  <c:v>Pre</c:v>
                </c:pt>
                <c:pt idx="7">
                  <c:v>NGT</c:v>
                </c:pt>
                <c:pt idx="8">
                  <c:v>Pre</c:v>
                </c:pt>
                <c:pt idx="10">
                  <c:v>NGT</c:v>
                </c:pt>
                <c:pt idx="11">
                  <c:v>Pre</c:v>
                </c:pt>
                <c:pt idx="13">
                  <c:v>NGT</c:v>
                </c:pt>
                <c:pt idx="14">
                  <c:v>Pre</c:v>
                </c:pt>
                <c:pt idx="16">
                  <c:v>NGT</c:v>
                </c:pt>
                <c:pt idx="17">
                  <c:v>Pre</c:v>
                </c:pt>
              </c:strCache>
            </c:strRef>
          </c:cat>
          <c:val>
            <c:numRef>
              <c:f>Sheet1!$B$2:$B$19</c:f>
              <c:numCache>
                <c:formatCode>General</c:formatCode>
                <c:ptCount val="18"/>
                <c:pt idx="1">
                  <c:v>0.48080000000000017</c:v>
                </c:pt>
                <c:pt idx="2">
                  <c:v>0.56670000000000031</c:v>
                </c:pt>
                <c:pt idx="4">
                  <c:v>0.32690000000000025</c:v>
                </c:pt>
                <c:pt idx="5">
                  <c:v>0.5111</c:v>
                </c:pt>
                <c:pt idx="7">
                  <c:v>6.6699999999999995E-2</c:v>
                </c:pt>
                <c:pt idx="8">
                  <c:v>0.15000000000000008</c:v>
                </c:pt>
                <c:pt idx="10">
                  <c:v>0.12820000000000001</c:v>
                </c:pt>
                <c:pt idx="11">
                  <c:v>5.8800000000000012E-2</c:v>
                </c:pt>
                <c:pt idx="13">
                  <c:v>0.53490000000000004</c:v>
                </c:pt>
                <c:pt idx="14">
                  <c:v>0.45329999999999998</c:v>
                </c:pt>
                <c:pt idx="16">
                  <c:v>0.31110000000000021</c:v>
                </c:pt>
                <c:pt idx="17">
                  <c:v>0.50670000000000004</c:v>
                </c:pt>
              </c:numCache>
            </c:numRef>
          </c:val>
        </c:ser>
        <c:gapWidth val="16"/>
        <c:overlap val="100"/>
        <c:axId val="49636480"/>
        <c:axId val="49656576"/>
      </c:barChart>
      <c:catAx>
        <c:axId val="49636480"/>
        <c:scaling>
          <c:orientation val="minMax"/>
        </c:scaling>
        <c:axPos val="b"/>
        <c:numFmt formatCode="General" sourceLinked="0"/>
        <c:tickLblPos val="nextTo"/>
        <c:txPr>
          <a:bodyPr/>
          <a:lstStyle/>
          <a:p>
            <a:pPr>
              <a:defRPr sz="1200" baseline="0">
                <a:latin typeface="Arial" panose="020B0604020202020204" pitchFamily="34" charset="0"/>
              </a:defRPr>
            </a:pPr>
            <a:endParaRPr lang="en-US"/>
          </a:p>
        </c:txPr>
        <c:crossAx val="49656576"/>
        <c:crosses val="autoZero"/>
        <c:auto val="1"/>
        <c:lblAlgn val="ctr"/>
        <c:lblOffset val="100"/>
      </c:catAx>
      <c:valAx>
        <c:axId val="49656576"/>
        <c:scaling>
          <c:orientation val="minMax"/>
          <c:max val="0.7000000000000004"/>
        </c:scaling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 smtClean="0"/>
                  <a:t>Frequency</a:t>
                </a:r>
                <a:endParaRPr lang="en-US" dirty="0"/>
              </a:p>
            </c:rich>
          </c:tx>
          <c:layout/>
        </c:title>
        <c:numFmt formatCode="0%" sourceLinked="0"/>
        <c:tickLblPos val="nextTo"/>
        <c:txPr>
          <a:bodyPr/>
          <a:lstStyle/>
          <a:p>
            <a:pPr>
              <a:defRPr sz="16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49636480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1800"/>
      </a:pPr>
      <a:endParaRPr lang="en-US"/>
    </a:p>
  </c:txPr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6921</cdr:x>
      <cdr:y>0.36281</cdr:y>
    </cdr:from>
    <cdr:to>
      <cdr:x>0.24181</cdr:x>
      <cdr:y>0.41939</cdr:y>
    </cdr:to>
    <cdr:sp macro="" textlink="">
      <cdr:nvSpPr>
        <cdr:cNvPr id="2" name="TextBox 2"/>
        <cdr:cNvSpPr txBox="1"/>
      </cdr:nvSpPr>
      <cdr:spPr>
        <a:xfrm xmlns:a="http://schemas.openxmlformats.org/drawingml/2006/main">
          <a:off x="1334477" y="1578708"/>
          <a:ext cx="572593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78/193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21248</cdr:x>
      <cdr:y>0.1045</cdr:y>
    </cdr:from>
    <cdr:to>
      <cdr:x>0.29403</cdr:x>
      <cdr:y>0.16109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675766" y="454733"/>
          <a:ext cx="643125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156/256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30957</cdr:x>
      <cdr:y>0.57666</cdr:y>
    </cdr:from>
    <cdr:to>
      <cdr:x>0.38217</cdr:x>
      <cdr:y>0.63324</cdr:y>
    </cdr:to>
    <cdr:sp macro="" textlink="">
      <cdr:nvSpPr>
        <cdr:cNvPr id="4" name="TextBox 2"/>
        <cdr:cNvSpPr txBox="1"/>
      </cdr:nvSpPr>
      <cdr:spPr>
        <a:xfrm xmlns:a="http://schemas.openxmlformats.org/drawingml/2006/main">
          <a:off x="2441486" y="2509229"/>
          <a:ext cx="572593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45/193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35364</cdr:x>
      <cdr:y>0.36291</cdr:y>
    </cdr:from>
    <cdr:to>
      <cdr:x>0.43518</cdr:x>
      <cdr:y>0.4195</cdr:y>
    </cdr:to>
    <cdr:sp macro="" textlink="">
      <cdr:nvSpPr>
        <cdr:cNvPr id="5" name="TextBox 2"/>
        <cdr:cNvSpPr txBox="1"/>
      </cdr:nvSpPr>
      <cdr:spPr>
        <a:xfrm xmlns:a="http://schemas.openxmlformats.org/drawingml/2006/main">
          <a:off x="2789015" y="1579164"/>
          <a:ext cx="643125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104/255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529</cdr:x>
      <cdr:y>0.84453</cdr:y>
    </cdr:from>
    <cdr:to>
      <cdr:x>0.52103</cdr:x>
      <cdr:y>0.90112</cdr:y>
    </cdr:to>
    <cdr:sp macro="" textlink="">
      <cdr:nvSpPr>
        <cdr:cNvPr id="6" name="TextBox 2"/>
        <cdr:cNvSpPr txBox="1"/>
      </cdr:nvSpPr>
      <cdr:spPr>
        <a:xfrm xmlns:a="http://schemas.openxmlformats.org/drawingml/2006/main">
          <a:off x="3571894" y="3674847"/>
          <a:ext cx="537327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3/133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9998</cdr:x>
      <cdr:y>0.75354</cdr:y>
    </cdr:from>
    <cdr:to>
      <cdr:x>0.57258</cdr:x>
      <cdr:y>0.81013</cdr:y>
    </cdr:to>
    <cdr:sp macro="" textlink="">
      <cdr:nvSpPr>
        <cdr:cNvPr id="7" name="TextBox 2"/>
        <cdr:cNvSpPr txBox="1"/>
      </cdr:nvSpPr>
      <cdr:spPr>
        <a:xfrm xmlns:a="http://schemas.openxmlformats.org/drawingml/2006/main">
          <a:off x="3943192" y="3278917"/>
          <a:ext cx="572593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17/179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59825</cdr:x>
      <cdr:y>0.78789</cdr:y>
    </cdr:from>
    <cdr:to>
      <cdr:x>0.66191</cdr:x>
      <cdr:y>0.84448</cdr:y>
    </cdr:to>
    <cdr:sp macro="" textlink="">
      <cdr:nvSpPr>
        <cdr:cNvPr id="8" name="TextBox 2"/>
        <cdr:cNvSpPr txBox="1"/>
      </cdr:nvSpPr>
      <cdr:spPr>
        <a:xfrm xmlns:a="http://schemas.openxmlformats.org/drawingml/2006/main">
          <a:off x="4718256" y="3428394"/>
          <a:ext cx="502061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9/135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4137</cdr:x>
      <cdr:y>0.6647</cdr:y>
    </cdr:from>
    <cdr:to>
      <cdr:x>0.71397</cdr:x>
      <cdr:y>0.72129</cdr:y>
    </cdr:to>
    <cdr:sp macro="" textlink="">
      <cdr:nvSpPr>
        <cdr:cNvPr id="9" name="TextBox 2"/>
        <cdr:cNvSpPr txBox="1"/>
      </cdr:nvSpPr>
      <cdr:spPr>
        <a:xfrm xmlns:a="http://schemas.openxmlformats.org/drawingml/2006/main">
          <a:off x="5058293" y="2892343"/>
          <a:ext cx="572593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27/163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7329</cdr:x>
      <cdr:y>0.6538</cdr:y>
    </cdr:from>
    <cdr:to>
      <cdr:x>0.8055</cdr:x>
      <cdr:y>0.71038</cdr:y>
    </cdr:to>
    <cdr:sp macro="" textlink="">
      <cdr:nvSpPr>
        <cdr:cNvPr id="10" name="TextBox 2"/>
        <cdr:cNvSpPr txBox="1"/>
      </cdr:nvSpPr>
      <cdr:spPr>
        <a:xfrm xmlns:a="http://schemas.openxmlformats.org/drawingml/2006/main">
          <a:off x="5780178" y="2844884"/>
          <a:ext cx="572593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27/154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78088</cdr:x>
      <cdr:y>0.52614</cdr:y>
    </cdr:from>
    <cdr:to>
      <cdr:x>0.85348</cdr:x>
      <cdr:y>0.58273</cdr:y>
    </cdr:to>
    <cdr:sp macro="" textlink="">
      <cdr:nvSpPr>
        <cdr:cNvPr id="11" name="TextBox 2"/>
        <cdr:cNvSpPr txBox="1"/>
      </cdr:nvSpPr>
      <cdr:spPr>
        <a:xfrm xmlns:a="http://schemas.openxmlformats.org/drawingml/2006/main">
          <a:off x="6158566" y="2289413"/>
          <a:ext cx="572593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59/212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7608</cdr:x>
      <cdr:y>0.74606</cdr:y>
    </cdr:from>
    <cdr:to>
      <cdr:x>0.94868</cdr:x>
      <cdr:y>0.80264</cdr:y>
    </cdr:to>
    <cdr:sp macro="" textlink="">
      <cdr:nvSpPr>
        <cdr:cNvPr id="12" name="TextBox 2"/>
        <cdr:cNvSpPr txBox="1"/>
      </cdr:nvSpPr>
      <cdr:spPr>
        <a:xfrm xmlns:a="http://schemas.openxmlformats.org/drawingml/2006/main">
          <a:off x="6909380" y="3246338"/>
          <a:ext cx="572593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17/173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92213</cdr:x>
      <cdr:y>0.48045</cdr:y>
    </cdr:from>
    <cdr:to>
      <cdr:x>0.99473</cdr:x>
      <cdr:y>0.53704</cdr:y>
    </cdr:to>
    <cdr:sp macro="" textlink="">
      <cdr:nvSpPr>
        <cdr:cNvPr id="13" name="TextBox 2"/>
        <cdr:cNvSpPr txBox="1"/>
      </cdr:nvSpPr>
      <cdr:spPr>
        <a:xfrm xmlns:a="http://schemas.openxmlformats.org/drawingml/2006/main">
          <a:off x="7272540" y="2090602"/>
          <a:ext cx="572593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69/221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17591</cdr:x>
      <cdr:y>0.26558</cdr:y>
    </cdr:from>
    <cdr:to>
      <cdr:x>0.23957</cdr:x>
      <cdr:y>0.32216</cdr:y>
    </cdr:to>
    <cdr:sp macro="" textlink="">
      <cdr:nvSpPr>
        <cdr:cNvPr id="2" name="TextBox 2"/>
        <cdr:cNvSpPr txBox="1"/>
      </cdr:nvSpPr>
      <cdr:spPr>
        <a:xfrm xmlns:a="http://schemas.openxmlformats.org/drawingml/2006/main">
          <a:off x="1387379" y="1155613"/>
          <a:ext cx="502061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25/52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21987</cdr:x>
      <cdr:y>0.15876</cdr:y>
    </cdr:from>
    <cdr:to>
      <cdr:x>0.28353</cdr:x>
      <cdr:y>0.21534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734049" y="690804"/>
          <a:ext cx="502061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51/90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31319</cdr:x>
      <cdr:y>0.45923</cdr:y>
    </cdr:from>
    <cdr:to>
      <cdr:x>0.37685</cdr:x>
      <cdr:y>0.51582</cdr:y>
    </cdr:to>
    <cdr:sp macro="" textlink="">
      <cdr:nvSpPr>
        <cdr:cNvPr id="4" name="TextBox 2"/>
        <cdr:cNvSpPr txBox="1"/>
      </cdr:nvSpPr>
      <cdr:spPr>
        <a:xfrm xmlns:a="http://schemas.openxmlformats.org/drawingml/2006/main">
          <a:off x="2470036" y="1998265"/>
          <a:ext cx="502061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17/52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36521</cdr:x>
      <cdr:y>0.22953</cdr:y>
    </cdr:from>
    <cdr:to>
      <cdr:x>0.42887</cdr:x>
      <cdr:y>0.28611</cdr:y>
    </cdr:to>
    <cdr:sp macro="" textlink="">
      <cdr:nvSpPr>
        <cdr:cNvPr id="5" name="TextBox 2"/>
        <cdr:cNvSpPr txBox="1"/>
      </cdr:nvSpPr>
      <cdr:spPr>
        <a:xfrm xmlns:a="http://schemas.openxmlformats.org/drawingml/2006/main">
          <a:off x="2880275" y="998742"/>
          <a:ext cx="502061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46/90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6122</cdr:x>
      <cdr:y>0.79194</cdr:y>
    </cdr:from>
    <cdr:to>
      <cdr:x>0.51594</cdr:x>
      <cdr:y>0.84852</cdr:y>
    </cdr:to>
    <cdr:sp macro="" textlink="">
      <cdr:nvSpPr>
        <cdr:cNvPr id="6" name="TextBox 2"/>
        <cdr:cNvSpPr txBox="1"/>
      </cdr:nvSpPr>
      <cdr:spPr>
        <a:xfrm xmlns:a="http://schemas.openxmlformats.org/drawingml/2006/main">
          <a:off x="3637512" y="3445996"/>
          <a:ext cx="431528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2/30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50661</cdr:x>
      <cdr:y>0.68595</cdr:y>
    </cdr:from>
    <cdr:to>
      <cdr:x>0.56132</cdr:x>
      <cdr:y>0.74254</cdr:y>
    </cdr:to>
    <cdr:sp macro="" textlink="">
      <cdr:nvSpPr>
        <cdr:cNvPr id="7" name="TextBox 2"/>
        <cdr:cNvSpPr txBox="1"/>
      </cdr:nvSpPr>
      <cdr:spPr>
        <a:xfrm xmlns:a="http://schemas.openxmlformats.org/drawingml/2006/main">
          <a:off x="3995455" y="2984816"/>
          <a:ext cx="431528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9/60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0167</cdr:x>
      <cdr:y>0.71059</cdr:y>
    </cdr:from>
    <cdr:to>
      <cdr:x>0.65639</cdr:x>
      <cdr:y>0.76717</cdr:y>
    </cdr:to>
    <cdr:sp macro="" textlink="">
      <cdr:nvSpPr>
        <cdr:cNvPr id="8" name="TextBox 2"/>
        <cdr:cNvSpPr txBox="1"/>
      </cdr:nvSpPr>
      <cdr:spPr>
        <a:xfrm xmlns:a="http://schemas.openxmlformats.org/drawingml/2006/main">
          <a:off x="4745198" y="3092002"/>
          <a:ext cx="431528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5/39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5044</cdr:x>
      <cdr:y>0.79954</cdr:y>
    </cdr:from>
    <cdr:to>
      <cdr:x>0.70516</cdr:x>
      <cdr:y>0.85613</cdr:y>
    </cdr:to>
    <cdr:sp macro="" textlink="">
      <cdr:nvSpPr>
        <cdr:cNvPr id="9" name="TextBox 2"/>
        <cdr:cNvSpPr txBox="1"/>
      </cdr:nvSpPr>
      <cdr:spPr>
        <a:xfrm xmlns:a="http://schemas.openxmlformats.org/drawingml/2006/main">
          <a:off x="5129818" y="3479080"/>
          <a:ext cx="431528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4/68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73835</cdr:x>
      <cdr:y>0.19796</cdr:y>
    </cdr:from>
    <cdr:to>
      <cdr:x>0.80201</cdr:x>
      <cdr:y>0.25454</cdr:y>
    </cdr:to>
    <cdr:sp macro="" textlink="">
      <cdr:nvSpPr>
        <cdr:cNvPr id="10" name="TextBox 2"/>
        <cdr:cNvSpPr txBox="1"/>
      </cdr:nvSpPr>
      <cdr:spPr>
        <a:xfrm xmlns:a="http://schemas.openxmlformats.org/drawingml/2006/main">
          <a:off x="5823152" y="861381"/>
          <a:ext cx="502061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23/43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78528</cdr:x>
      <cdr:y>0.30649</cdr:y>
    </cdr:from>
    <cdr:to>
      <cdr:x>0.84894</cdr:x>
      <cdr:y>0.36308</cdr:y>
    </cdr:to>
    <cdr:sp macro="" textlink="">
      <cdr:nvSpPr>
        <cdr:cNvPr id="11" name="TextBox 2"/>
        <cdr:cNvSpPr txBox="1"/>
      </cdr:nvSpPr>
      <cdr:spPr>
        <a:xfrm xmlns:a="http://schemas.openxmlformats.org/drawingml/2006/main">
          <a:off x="6193268" y="1333659"/>
          <a:ext cx="502061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34/75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7871</cdr:x>
      <cdr:y>0.48008</cdr:y>
    </cdr:from>
    <cdr:to>
      <cdr:x>0.94237</cdr:x>
      <cdr:y>0.53667</cdr:y>
    </cdr:to>
    <cdr:sp macro="" textlink="">
      <cdr:nvSpPr>
        <cdr:cNvPr id="12" name="TextBox 2"/>
        <cdr:cNvSpPr txBox="1"/>
      </cdr:nvSpPr>
      <cdr:spPr>
        <a:xfrm xmlns:a="http://schemas.openxmlformats.org/drawingml/2006/main">
          <a:off x="6930115" y="2088999"/>
          <a:ext cx="502061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14/45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92479</cdr:x>
      <cdr:y>0.23365</cdr:y>
    </cdr:from>
    <cdr:to>
      <cdr:x>0.98845</cdr:x>
      <cdr:y>0.29023</cdr:y>
    </cdr:to>
    <cdr:sp macro="" textlink="">
      <cdr:nvSpPr>
        <cdr:cNvPr id="13" name="TextBox 2"/>
        <cdr:cNvSpPr txBox="1"/>
      </cdr:nvSpPr>
      <cdr:spPr>
        <a:xfrm xmlns:a="http://schemas.openxmlformats.org/drawingml/2006/main">
          <a:off x="7293541" y="1016674"/>
          <a:ext cx="502061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00" dirty="0" smtClean="0">
              <a:latin typeface="Arial" panose="020B0604020202020204" pitchFamily="34" charset="0"/>
              <a:cs typeface="Arial" panose="020B0604020202020204" pitchFamily="34" charset="0"/>
            </a:rPr>
            <a:t>38/75</a:t>
          </a:r>
          <a:endParaRPr lang="en-US" sz="1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82742" cy="46498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7513" y="1"/>
            <a:ext cx="2982742" cy="46498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A5FAB4-4B76-46BA-AD8C-026B1AC92B03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17600" y="696913"/>
            <a:ext cx="4646613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805" y="4416510"/>
            <a:ext cx="5504204" cy="418322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823"/>
            <a:ext cx="2982742" cy="46498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7513" y="8829823"/>
            <a:ext cx="2982742" cy="46498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7B3055-741F-4B2A-8156-4A43824E58B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427388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668E8-3692-41E2-A77B-4E4D3F2E997D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46407-DF05-421D-8B93-696F6BB6FEF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8702578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668E8-3692-41E2-A77B-4E4D3F2E997D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46407-DF05-421D-8B93-696F6BB6FEF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4006843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668E8-3692-41E2-A77B-4E4D3F2E997D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46407-DF05-421D-8B93-696F6BB6FEF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374525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668E8-3692-41E2-A77B-4E4D3F2E997D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46407-DF05-421D-8B93-696F6BB6FEF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46538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668E8-3692-41E2-A77B-4E4D3F2E997D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46407-DF05-421D-8B93-696F6BB6FEF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9280961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668E8-3692-41E2-A77B-4E4D3F2E997D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46407-DF05-421D-8B93-696F6BB6FEF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063366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668E8-3692-41E2-A77B-4E4D3F2E997D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46407-DF05-421D-8B93-696F6BB6FEF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196717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668E8-3692-41E2-A77B-4E4D3F2E997D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46407-DF05-421D-8B93-696F6BB6FEF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7235550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668E8-3692-41E2-A77B-4E4D3F2E997D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46407-DF05-421D-8B93-696F6BB6FEF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075521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668E8-3692-41E2-A77B-4E4D3F2E997D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46407-DF05-421D-8B93-696F6BB6FEF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7611989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A668E8-3692-41E2-A77B-4E4D3F2E997D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46407-DF05-421D-8B93-696F6BB6FEF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92939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A668E8-3692-41E2-A77B-4E4D3F2E997D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C46407-DF05-421D-8B93-696F6BB6FEF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5189511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4" r:id="rId1"/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xmlns="" val="4084345029"/>
              </p:ext>
            </p:extLst>
          </p:nvPr>
        </p:nvGraphicFramePr>
        <p:xfrm>
          <a:off x="609600" y="1143000"/>
          <a:ext cx="78867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" name="Group 1"/>
          <p:cNvGrpSpPr/>
          <p:nvPr/>
        </p:nvGrpSpPr>
        <p:grpSpPr>
          <a:xfrm>
            <a:off x="1905000" y="5410200"/>
            <a:ext cx="6477000" cy="584775"/>
            <a:chOff x="2104592" y="5410200"/>
            <a:chExt cx="6277408" cy="584775"/>
          </a:xfrm>
        </p:grpSpPr>
        <p:sp>
          <p:nvSpPr>
            <p:cNvPr id="5" name="TextBox 4"/>
            <p:cNvSpPr txBox="1"/>
            <p:nvPr/>
          </p:nvSpPr>
          <p:spPr>
            <a:xfrm>
              <a:off x="7543800" y="5410200"/>
              <a:ext cx="83820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leep</a:t>
              </a:r>
            </a:p>
            <a:p>
              <a:pPr algn="ctr"/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pnea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104592" y="5533310"/>
              <a:ext cx="9144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besity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958033" y="5533310"/>
              <a:ext cx="14478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ypertension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277031" y="5410200"/>
              <a:ext cx="99060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ortic</a:t>
              </a:r>
            </a:p>
            <a:p>
              <a:pPr algn="ctr"/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iffness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267631" y="5410200"/>
              <a:ext cx="112037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LV</a:t>
              </a:r>
            </a:p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Mass/Ht</a:t>
              </a:r>
              <a:r>
                <a:rPr lang="en-US" sz="1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.7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326073" y="5410200"/>
              <a:ext cx="1217727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active</a:t>
              </a:r>
            </a:p>
            <a:p>
              <a:pPr algn="ctr"/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yperemia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600200" y="838200"/>
            <a:ext cx="10633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Women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977483" y="6162907"/>
            <a:ext cx="8290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 &lt; 0.0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129775" y="6162907"/>
            <a:ext cx="8290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 &lt; 0.0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270140" y="6162907"/>
            <a:ext cx="8290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 = 0.01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330282" y="6162907"/>
            <a:ext cx="8290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 = 0.009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482574" y="6162907"/>
            <a:ext cx="8290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 = 0.02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627433" y="6162907"/>
            <a:ext cx="8290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 &lt; 0.0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981200" y="5921298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MI ≥ 3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224454" y="5921298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WV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≥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2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244789" y="5921298"/>
            <a:ext cx="10550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m/m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.7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≥ 5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486291" y="5921298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HI ≤1.6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363521" y="5928733"/>
            <a:ext cx="14123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HI ≥ 15 or CPA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5198750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xmlns="" val="2823738688"/>
              </p:ext>
            </p:extLst>
          </p:nvPr>
        </p:nvGraphicFramePr>
        <p:xfrm>
          <a:off x="609600" y="1143000"/>
          <a:ext cx="78867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" name="Group 1"/>
          <p:cNvGrpSpPr/>
          <p:nvPr/>
        </p:nvGrpSpPr>
        <p:grpSpPr>
          <a:xfrm>
            <a:off x="1981200" y="5410200"/>
            <a:ext cx="6400800" cy="584775"/>
            <a:chOff x="2104592" y="5410200"/>
            <a:chExt cx="6277408" cy="584775"/>
          </a:xfrm>
        </p:grpSpPr>
        <p:sp>
          <p:nvSpPr>
            <p:cNvPr id="5" name="TextBox 4"/>
            <p:cNvSpPr txBox="1"/>
            <p:nvPr/>
          </p:nvSpPr>
          <p:spPr>
            <a:xfrm>
              <a:off x="7543800" y="5410200"/>
              <a:ext cx="83820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leep</a:t>
              </a:r>
            </a:p>
            <a:p>
              <a:pPr algn="ctr"/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pnea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104592" y="5533310"/>
              <a:ext cx="9144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besity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958033" y="5533310"/>
              <a:ext cx="14478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ypertension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277031" y="5410200"/>
              <a:ext cx="99060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ortic</a:t>
              </a:r>
            </a:p>
            <a:p>
              <a:pPr algn="ctr"/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tiffness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267632" y="5410200"/>
              <a:ext cx="109663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LV</a:t>
              </a:r>
            </a:p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Mass/Ht</a:t>
              </a:r>
              <a:r>
                <a:rPr lang="en-US" sz="1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.7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326073" y="5410200"/>
              <a:ext cx="1217727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active</a:t>
              </a:r>
            </a:p>
            <a:p>
              <a:pPr algn="ctr"/>
              <a:r>
                <a:rPr lang="en-US" sz="1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yperemia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1600200" y="838200"/>
            <a:ext cx="6832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Men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977483" y="6162907"/>
            <a:ext cx="8290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 = 0.32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129775" y="6162907"/>
            <a:ext cx="8290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 = 0.018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275846" y="6162907"/>
            <a:ext cx="817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 = 0.11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357801" y="6162907"/>
            <a:ext cx="8290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 = 0.28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507677" y="6162907"/>
            <a:ext cx="8290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 = 0.39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7655171" y="6162907"/>
            <a:ext cx="8290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 = 0.036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991910" y="5917581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MI ≥ 3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224454" y="5917581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WV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≥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2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484433" y="5917581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HI ≤1.6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363520" y="5917581"/>
            <a:ext cx="14123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HI ≥ 15 or CPAP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244789" y="5917581"/>
            <a:ext cx="10550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≥ 56 gm/m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.7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516578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124</TotalTime>
  <Words>119</Words>
  <Application>Microsoft Office PowerPoint</Application>
  <PresentationFormat>On-screen Show (4:3)</PresentationFormat>
  <Paragraphs>7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Company>UT School of Public Health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is, Craig L</dc:creator>
  <cp:lastModifiedBy>0011692</cp:lastModifiedBy>
  <cp:revision>92</cp:revision>
  <cp:lastPrinted>2015-06-12T15:07:51Z</cp:lastPrinted>
  <dcterms:created xsi:type="dcterms:W3CDTF">2014-08-15T17:24:42Z</dcterms:created>
  <dcterms:modified xsi:type="dcterms:W3CDTF">2016-06-01T02:19:06Z</dcterms:modified>
</cp:coreProperties>
</file>